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86" r:id="rId22"/>
    <p:sldId id="277" r:id="rId23"/>
    <p:sldId id="278" r:id="rId24"/>
    <p:sldId id="279" r:id="rId25"/>
    <p:sldId id="280" r:id="rId26"/>
    <p:sldId id="281" r:id="rId27"/>
    <p:sldId id="282" r:id="rId28"/>
    <p:sldId id="283" r:id="rId29"/>
    <p:sldId id="284" r:id="rId30"/>
    <p:sldId id="285" r:id="rId31"/>
  </p:sldIdLst>
  <p:sldSz cx="3419475" cy="457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41" userDrawn="1">
          <p15:clr>
            <a:srgbClr val="A4A3A4"/>
          </p15:clr>
        </p15:guide>
        <p15:guide id="2" pos="107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39" autoAdjust="0"/>
    <p:restoredTop sz="94660"/>
  </p:normalViewPr>
  <p:slideViewPr>
    <p:cSldViewPr snapToGrid="0" showGuides="1">
      <p:cViewPr varScale="1">
        <p:scale>
          <a:sx n="127" d="100"/>
          <a:sy n="127" d="100"/>
        </p:scale>
        <p:origin x="2554" y="91"/>
      </p:cViewPr>
      <p:guideLst>
        <p:guide orient="horz" pos="1441"/>
        <p:guide pos="107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56461" y="748242"/>
            <a:ext cx="2906554" cy="1591733"/>
          </a:xfrm>
        </p:spPr>
        <p:txBody>
          <a:bodyPr anchor="b"/>
          <a:lstStyle>
            <a:lvl1pPr algn="ctr">
              <a:defRPr sz="224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27435" y="2401359"/>
            <a:ext cx="2564606" cy="1103841"/>
          </a:xfrm>
        </p:spPr>
        <p:txBody>
          <a:bodyPr/>
          <a:lstStyle>
            <a:lvl1pPr marL="0" indent="0" algn="ctr">
              <a:buNone/>
              <a:defRPr sz="898"/>
            </a:lvl1pPr>
            <a:lvl2pPr marL="170993" indent="0" algn="ctr">
              <a:buNone/>
              <a:defRPr sz="748"/>
            </a:lvl2pPr>
            <a:lvl3pPr marL="341986" indent="0" algn="ctr">
              <a:buNone/>
              <a:defRPr sz="673"/>
            </a:lvl3pPr>
            <a:lvl4pPr marL="512978" indent="0" algn="ctr">
              <a:buNone/>
              <a:defRPr sz="598"/>
            </a:lvl4pPr>
            <a:lvl5pPr marL="683971" indent="0" algn="ctr">
              <a:buNone/>
              <a:defRPr sz="598"/>
            </a:lvl5pPr>
            <a:lvl6pPr marL="854964" indent="0" algn="ctr">
              <a:buNone/>
              <a:defRPr sz="598"/>
            </a:lvl6pPr>
            <a:lvl7pPr marL="1025957" indent="0" algn="ctr">
              <a:buNone/>
              <a:defRPr sz="598"/>
            </a:lvl7pPr>
            <a:lvl8pPr marL="1196950" indent="0" algn="ctr">
              <a:buNone/>
              <a:defRPr sz="598"/>
            </a:lvl8pPr>
            <a:lvl9pPr marL="1367942" indent="0" algn="ctr">
              <a:buNone/>
              <a:defRPr sz="598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0A32BB-1EBA-468C-8A0E-444A99DFF434}" type="datetimeFigureOut">
              <a:rPr lang="zh-CN" altLang="en-US" smtClean="0"/>
              <a:t>2020/1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25040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0A32BB-1EBA-468C-8A0E-444A99DFF434}" type="datetimeFigureOut">
              <a:rPr lang="zh-CN" altLang="en-US" smtClean="0"/>
              <a:t>2020/1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8364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447062" y="243417"/>
            <a:ext cx="737324" cy="387455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35089" y="243417"/>
            <a:ext cx="2169229" cy="387455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0A32BB-1EBA-468C-8A0E-444A99DFF434}" type="datetimeFigureOut">
              <a:rPr lang="zh-CN" altLang="en-US" smtClean="0"/>
              <a:t>2020/1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5548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0A32BB-1EBA-468C-8A0E-444A99DFF434}" type="datetimeFigureOut">
              <a:rPr lang="zh-CN" altLang="en-US" smtClean="0"/>
              <a:t>2020/1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604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3308" y="1139826"/>
            <a:ext cx="2949297" cy="1901825"/>
          </a:xfrm>
        </p:spPr>
        <p:txBody>
          <a:bodyPr anchor="b"/>
          <a:lstStyle>
            <a:lvl1pPr>
              <a:defRPr sz="224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33308" y="3059643"/>
            <a:ext cx="2949297" cy="1000125"/>
          </a:xfrm>
        </p:spPr>
        <p:txBody>
          <a:bodyPr/>
          <a:lstStyle>
            <a:lvl1pPr marL="0" indent="0">
              <a:buNone/>
              <a:defRPr sz="898">
                <a:solidFill>
                  <a:schemeClr val="tx1"/>
                </a:solidFill>
              </a:defRPr>
            </a:lvl1pPr>
            <a:lvl2pPr marL="170993" indent="0">
              <a:buNone/>
              <a:defRPr sz="748">
                <a:solidFill>
                  <a:schemeClr val="tx1">
                    <a:tint val="75000"/>
                  </a:schemeClr>
                </a:solidFill>
              </a:defRPr>
            </a:lvl2pPr>
            <a:lvl3pPr marL="341986" indent="0">
              <a:buNone/>
              <a:defRPr sz="673">
                <a:solidFill>
                  <a:schemeClr val="tx1">
                    <a:tint val="75000"/>
                  </a:schemeClr>
                </a:solidFill>
              </a:defRPr>
            </a:lvl3pPr>
            <a:lvl4pPr marL="512978" indent="0">
              <a:buNone/>
              <a:defRPr sz="598">
                <a:solidFill>
                  <a:schemeClr val="tx1">
                    <a:tint val="75000"/>
                  </a:schemeClr>
                </a:solidFill>
              </a:defRPr>
            </a:lvl4pPr>
            <a:lvl5pPr marL="683971" indent="0">
              <a:buNone/>
              <a:defRPr sz="598">
                <a:solidFill>
                  <a:schemeClr val="tx1">
                    <a:tint val="75000"/>
                  </a:schemeClr>
                </a:solidFill>
              </a:defRPr>
            </a:lvl5pPr>
            <a:lvl6pPr marL="854964" indent="0">
              <a:buNone/>
              <a:defRPr sz="598">
                <a:solidFill>
                  <a:schemeClr val="tx1">
                    <a:tint val="75000"/>
                  </a:schemeClr>
                </a:solidFill>
              </a:defRPr>
            </a:lvl6pPr>
            <a:lvl7pPr marL="1025957" indent="0">
              <a:buNone/>
              <a:defRPr sz="598">
                <a:solidFill>
                  <a:schemeClr val="tx1">
                    <a:tint val="75000"/>
                  </a:schemeClr>
                </a:solidFill>
              </a:defRPr>
            </a:lvl7pPr>
            <a:lvl8pPr marL="1196950" indent="0">
              <a:buNone/>
              <a:defRPr sz="598">
                <a:solidFill>
                  <a:schemeClr val="tx1">
                    <a:tint val="75000"/>
                  </a:schemeClr>
                </a:solidFill>
              </a:defRPr>
            </a:lvl8pPr>
            <a:lvl9pPr marL="1367942" indent="0">
              <a:buNone/>
              <a:defRPr sz="59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0A32BB-1EBA-468C-8A0E-444A99DFF434}" type="datetimeFigureOut">
              <a:rPr lang="zh-CN" altLang="en-US" smtClean="0"/>
              <a:t>2020/1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8931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35089" y="1217083"/>
            <a:ext cx="1453277" cy="290089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731109" y="1217083"/>
            <a:ext cx="1453277" cy="290089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0A32BB-1EBA-468C-8A0E-444A99DFF434}" type="datetimeFigureOut">
              <a:rPr lang="zh-CN" altLang="en-US" smtClean="0"/>
              <a:t>2020/1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4366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5534" y="243418"/>
            <a:ext cx="2949297" cy="88370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35535" y="1120775"/>
            <a:ext cx="1446598" cy="549275"/>
          </a:xfrm>
        </p:spPr>
        <p:txBody>
          <a:bodyPr anchor="b"/>
          <a:lstStyle>
            <a:lvl1pPr marL="0" indent="0">
              <a:buNone/>
              <a:defRPr sz="898" b="1"/>
            </a:lvl1pPr>
            <a:lvl2pPr marL="170993" indent="0">
              <a:buNone/>
              <a:defRPr sz="748" b="1"/>
            </a:lvl2pPr>
            <a:lvl3pPr marL="341986" indent="0">
              <a:buNone/>
              <a:defRPr sz="673" b="1"/>
            </a:lvl3pPr>
            <a:lvl4pPr marL="512978" indent="0">
              <a:buNone/>
              <a:defRPr sz="598" b="1"/>
            </a:lvl4pPr>
            <a:lvl5pPr marL="683971" indent="0">
              <a:buNone/>
              <a:defRPr sz="598" b="1"/>
            </a:lvl5pPr>
            <a:lvl6pPr marL="854964" indent="0">
              <a:buNone/>
              <a:defRPr sz="598" b="1"/>
            </a:lvl6pPr>
            <a:lvl7pPr marL="1025957" indent="0">
              <a:buNone/>
              <a:defRPr sz="598" b="1"/>
            </a:lvl7pPr>
            <a:lvl8pPr marL="1196950" indent="0">
              <a:buNone/>
              <a:defRPr sz="598" b="1"/>
            </a:lvl8pPr>
            <a:lvl9pPr marL="1367942" indent="0">
              <a:buNone/>
              <a:defRPr sz="598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5535" y="1670050"/>
            <a:ext cx="1446598" cy="245639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731110" y="1120775"/>
            <a:ext cx="1453722" cy="549275"/>
          </a:xfrm>
        </p:spPr>
        <p:txBody>
          <a:bodyPr anchor="b"/>
          <a:lstStyle>
            <a:lvl1pPr marL="0" indent="0">
              <a:buNone/>
              <a:defRPr sz="898" b="1"/>
            </a:lvl1pPr>
            <a:lvl2pPr marL="170993" indent="0">
              <a:buNone/>
              <a:defRPr sz="748" b="1"/>
            </a:lvl2pPr>
            <a:lvl3pPr marL="341986" indent="0">
              <a:buNone/>
              <a:defRPr sz="673" b="1"/>
            </a:lvl3pPr>
            <a:lvl4pPr marL="512978" indent="0">
              <a:buNone/>
              <a:defRPr sz="598" b="1"/>
            </a:lvl4pPr>
            <a:lvl5pPr marL="683971" indent="0">
              <a:buNone/>
              <a:defRPr sz="598" b="1"/>
            </a:lvl5pPr>
            <a:lvl6pPr marL="854964" indent="0">
              <a:buNone/>
              <a:defRPr sz="598" b="1"/>
            </a:lvl6pPr>
            <a:lvl7pPr marL="1025957" indent="0">
              <a:buNone/>
              <a:defRPr sz="598" b="1"/>
            </a:lvl7pPr>
            <a:lvl8pPr marL="1196950" indent="0">
              <a:buNone/>
              <a:defRPr sz="598" b="1"/>
            </a:lvl8pPr>
            <a:lvl9pPr marL="1367942" indent="0">
              <a:buNone/>
              <a:defRPr sz="598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731110" y="1670050"/>
            <a:ext cx="1453722" cy="245639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0A32BB-1EBA-468C-8A0E-444A99DFF434}" type="datetimeFigureOut">
              <a:rPr lang="zh-CN" altLang="en-US" smtClean="0"/>
              <a:t>2020/1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63559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0A32BB-1EBA-468C-8A0E-444A99DFF434}" type="datetimeFigureOut">
              <a:rPr lang="zh-CN" altLang="en-US" smtClean="0"/>
              <a:t>2020/1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36858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0A32BB-1EBA-468C-8A0E-444A99DFF434}" type="datetimeFigureOut">
              <a:rPr lang="zh-CN" altLang="en-US" smtClean="0"/>
              <a:t>2020/1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8324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5534" y="304800"/>
            <a:ext cx="1102870" cy="1066800"/>
          </a:xfrm>
        </p:spPr>
        <p:txBody>
          <a:bodyPr anchor="b"/>
          <a:lstStyle>
            <a:lvl1pPr>
              <a:defRPr sz="119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453722" y="658285"/>
            <a:ext cx="1731109" cy="3249083"/>
          </a:xfrm>
        </p:spPr>
        <p:txBody>
          <a:bodyPr/>
          <a:lstStyle>
            <a:lvl1pPr>
              <a:defRPr sz="1197"/>
            </a:lvl1pPr>
            <a:lvl2pPr>
              <a:defRPr sz="1047"/>
            </a:lvl2pPr>
            <a:lvl3pPr>
              <a:defRPr sz="898"/>
            </a:lvl3pPr>
            <a:lvl4pPr>
              <a:defRPr sz="748"/>
            </a:lvl4pPr>
            <a:lvl5pPr>
              <a:defRPr sz="748"/>
            </a:lvl5pPr>
            <a:lvl6pPr>
              <a:defRPr sz="748"/>
            </a:lvl6pPr>
            <a:lvl7pPr>
              <a:defRPr sz="748"/>
            </a:lvl7pPr>
            <a:lvl8pPr>
              <a:defRPr sz="748"/>
            </a:lvl8pPr>
            <a:lvl9pPr>
              <a:defRPr sz="74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5534" y="1371600"/>
            <a:ext cx="1102870" cy="2541059"/>
          </a:xfrm>
        </p:spPr>
        <p:txBody>
          <a:bodyPr/>
          <a:lstStyle>
            <a:lvl1pPr marL="0" indent="0">
              <a:buNone/>
              <a:defRPr sz="598"/>
            </a:lvl1pPr>
            <a:lvl2pPr marL="170993" indent="0">
              <a:buNone/>
              <a:defRPr sz="524"/>
            </a:lvl2pPr>
            <a:lvl3pPr marL="341986" indent="0">
              <a:buNone/>
              <a:defRPr sz="449"/>
            </a:lvl3pPr>
            <a:lvl4pPr marL="512978" indent="0">
              <a:buNone/>
              <a:defRPr sz="374"/>
            </a:lvl4pPr>
            <a:lvl5pPr marL="683971" indent="0">
              <a:buNone/>
              <a:defRPr sz="374"/>
            </a:lvl5pPr>
            <a:lvl6pPr marL="854964" indent="0">
              <a:buNone/>
              <a:defRPr sz="374"/>
            </a:lvl6pPr>
            <a:lvl7pPr marL="1025957" indent="0">
              <a:buNone/>
              <a:defRPr sz="374"/>
            </a:lvl7pPr>
            <a:lvl8pPr marL="1196950" indent="0">
              <a:buNone/>
              <a:defRPr sz="374"/>
            </a:lvl8pPr>
            <a:lvl9pPr marL="1367942" indent="0">
              <a:buNone/>
              <a:defRPr sz="37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0A32BB-1EBA-468C-8A0E-444A99DFF434}" type="datetimeFigureOut">
              <a:rPr lang="zh-CN" altLang="en-US" smtClean="0"/>
              <a:t>2020/1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0828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5534" y="304800"/>
            <a:ext cx="1102870" cy="1066800"/>
          </a:xfrm>
        </p:spPr>
        <p:txBody>
          <a:bodyPr anchor="b"/>
          <a:lstStyle>
            <a:lvl1pPr>
              <a:defRPr sz="119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453722" y="658285"/>
            <a:ext cx="1731109" cy="3249083"/>
          </a:xfrm>
        </p:spPr>
        <p:txBody>
          <a:bodyPr anchor="t"/>
          <a:lstStyle>
            <a:lvl1pPr marL="0" indent="0">
              <a:buNone/>
              <a:defRPr sz="1197"/>
            </a:lvl1pPr>
            <a:lvl2pPr marL="170993" indent="0">
              <a:buNone/>
              <a:defRPr sz="1047"/>
            </a:lvl2pPr>
            <a:lvl3pPr marL="341986" indent="0">
              <a:buNone/>
              <a:defRPr sz="898"/>
            </a:lvl3pPr>
            <a:lvl4pPr marL="512978" indent="0">
              <a:buNone/>
              <a:defRPr sz="748"/>
            </a:lvl4pPr>
            <a:lvl5pPr marL="683971" indent="0">
              <a:buNone/>
              <a:defRPr sz="748"/>
            </a:lvl5pPr>
            <a:lvl6pPr marL="854964" indent="0">
              <a:buNone/>
              <a:defRPr sz="748"/>
            </a:lvl6pPr>
            <a:lvl7pPr marL="1025957" indent="0">
              <a:buNone/>
              <a:defRPr sz="748"/>
            </a:lvl7pPr>
            <a:lvl8pPr marL="1196950" indent="0">
              <a:buNone/>
              <a:defRPr sz="748"/>
            </a:lvl8pPr>
            <a:lvl9pPr marL="1367942" indent="0">
              <a:buNone/>
              <a:defRPr sz="748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5534" y="1371600"/>
            <a:ext cx="1102870" cy="2541059"/>
          </a:xfrm>
        </p:spPr>
        <p:txBody>
          <a:bodyPr/>
          <a:lstStyle>
            <a:lvl1pPr marL="0" indent="0">
              <a:buNone/>
              <a:defRPr sz="598"/>
            </a:lvl1pPr>
            <a:lvl2pPr marL="170993" indent="0">
              <a:buNone/>
              <a:defRPr sz="524"/>
            </a:lvl2pPr>
            <a:lvl3pPr marL="341986" indent="0">
              <a:buNone/>
              <a:defRPr sz="449"/>
            </a:lvl3pPr>
            <a:lvl4pPr marL="512978" indent="0">
              <a:buNone/>
              <a:defRPr sz="374"/>
            </a:lvl4pPr>
            <a:lvl5pPr marL="683971" indent="0">
              <a:buNone/>
              <a:defRPr sz="374"/>
            </a:lvl5pPr>
            <a:lvl6pPr marL="854964" indent="0">
              <a:buNone/>
              <a:defRPr sz="374"/>
            </a:lvl6pPr>
            <a:lvl7pPr marL="1025957" indent="0">
              <a:buNone/>
              <a:defRPr sz="374"/>
            </a:lvl7pPr>
            <a:lvl8pPr marL="1196950" indent="0">
              <a:buNone/>
              <a:defRPr sz="374"/>
            </a:lvl8pPr>
            <a:lvl9pPr marL="1367942" indent="0">
              <a:buNone/>
              <a:defRPr sz="37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0A32BB-1EBA-468C-8A0E-444A99DFF434}" type="datetimeFigureOut">
              <a:rPr lang="zh-CN" altLang="en-US" smtClean="0"/>
              <a:t>2020/1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70900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35089" y="243418"/>
            <a:ext cx="2949297" cy="8837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35089" y="1217083"/>
            <a:ext cx="2949297" cy="29008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35089" y="4237568"/>
            <a:ext cx="769382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4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0A32BB-1EBA-468C-8A0E-444A99DFF434}" type="datetimeFigureOut">
              <a:rPr lang="zh-CN" altLang="en-US" smtClean="0"/>
              <a:t>2020/1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132701" y="4237568"/>
            <a:ext cx="1154073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4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415004" y="4237568"/>
            <a:ext cx="769382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4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AB4394-B1A0-46BA-9E74-C174EB4B0A0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56649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341986" rtl="0" eaLnBrk="1" latinLnBrk="0" hangingPunct="1">
        <a:lnSpc>
          <a:spcPct val="90000"/>
        </a:lnSpc>
        <a:spcBef>
          <a:spcPct val="0"/>
        </a:spcBef>
        <a:buNone/>
        <a:defRPr sz="164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5496" indent="-85496" algn="l" defTabSz="341986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047" kern="1200">
          <a:solidFill>
            <a:schemeClr val="tx1"/>
          </a:solidFill>
          <a:latin typeface="+mn-lt"/>
          <a:ea typeface="+mn-ea"/>
          <a:cs typeface="+mn-cs"/>
        </a:defRPr>
      </a:lvl1pPr>
      <a:lvl2pPr marL="256489" indent="-85496" algn="l" defTabSz="341986" rtl="0" eaLnBrk="1" latinLnBrk="0" hangingPunct="1">
        <a:lnSpc>
          <a:spcPct val="90000"/>
        </a:lnSpc>
        <a:spcBef>
          <a:spcPts val="187"/>
        </a:spcBef>
        <a:buFont typeface="Arial" panose="020B0604020202020204" pitchFamily="34" charset="0"/>
        <a:buChar char="•"/>
        <a:defRPr sz="898" kern="1200">
          <a:solidFill>
            <a:schemeClr val="tx1"/>
          </a:solidFill>
          <a:latin typeface="+mn-lt"/>
          <a:ea typeface="+mn-ea"/>
          <a:cs typeface="+mn-cs"/>
        </a:defRPr>
      </a:lvl2pPr>
      <a:lvl3pPr marL="427482" indent="-85496" algn="l" defTabSz="341986" rtl="0" eaLnBrk="1" latinLnBrk="0" hangingPunct="1">
        <a:lnSpc>
          <a:spcPct val="90000"/>
        </a:lnSpc>
        <a:spcBef>
          <a:spcPts val="187"/>
        </a:spcBef>
        <a:buFont typeface="Arial" panose="020B0604020202020204" pitchFamily="34" charset="0"/>
        <a:buChar char="•"/>
        <a:defRPr sz="748" kern="1200">
          <a:solidFill>
            <a:schemeClr val="tx1"/>
          </a:solidFill>
          <a:latin typeface="+mn-lt"/>
          <a:ea typeface="+mn-ea"/>
          <a:cs typeface="+mn-cs"/>
        </a:defRPr>
      </a:lvl3pPr>
      <a:lvl4pPr marL="598475" indent="-85496" algn="l" defTabSz="341986" rtl="0" eaLnBrk="1" latinLnBrk="0" hangingPunct="1">
        <a:lnSpc>
          <a:spcPct val="90000"/>
        </a:lnSpc>
        <a:spcBef>
          <a:spcPts val="187"/>
        </a:spcBef>
        <a:buFont typeface="Arial" panose="020B0604020202020204" pitchFamily="34" charset="0"/>
        <a:buChar char="•"/>
        <a:defRPr sz="673" kern="1200">
          <a:solidFill>
            <a:schemeClr val="tx1"/>
          </a:solidFill>
          <a:latin typeface="+mn-lt"/>
          <a:ea typeface="+mn-ea"/>
          <a:cs typeface="+mn-cs"/>
        </a:defRPr>
      </a:lvl4pPr>
      <a:lvl5pPr marL="769468" indent="-85496" algn="l" defTabSz="341986" rtl="0" eaLnBrk="1" latinLnBrk="0" hangingPunct="1">
        <a:lnSpc>
          <a:spcPct val="90000"/>
        </a:lnSpc>
        <a:spcBef>
          <a:spcPts val="187"/>
        </a:spcBef>
        <a:buFont typeface="Arial" panose="020B0604020202020204" pitchFamily="34" charset="0"/>
        <a:buChar char="•"/>
        <a:defRPr sz="673" kern="1200">
          <a:solidFill>
            <a:schemeClr val="tx1"/>
          </a:solidFill>
          <a:latin typeface="+mn-lt"/>
          <a:ea typeface="+mn-ea"/>
          <a:cs typeface="+mn-cs"/>
        </a:defRPr>
      </a:lvl5pPr>
      <a:lvl6pPr marL="940460" indent="-85496" algn="l" defTabSz="341986" rtl="0" eaLnBrk="1" latinLnBrk="0" hangingPunct="1">
        <a:lnSpc>
          <a:spcPct val="90000"/>
        </a:lnSpc>
        <a:spcBef>
          <a:spcPts val="187"/>
        </a:spcBef>
        <a:buFont typeface="Arial" panose="020B0604020202020204" pitchFamily="34" charset="0"/>
        <a:buChar char="•"/>
        <a:defRPr sz="673" kern="1200">
          <a:solidFill>
            <a:schemeClr val="tx1"/>
          </a:solidFill>
          <a:latin typeface="+mn-lt"/>
          <a:ea typeface="+mn-ea"/>
          <a:cs typeface="+mn-cs"/>
        </a:defRPr>
      </a:lvl6pPr>
      <a:lvl7pPr marL="1111453" indent="-85496" algn="l" defTabSz="341986" rtl="0" eaLnBrk="1" latinLnBrk="0" hangingPunct="1">
        <a:lnSpc>
          <a:spcPct val="90000"/>
        </a:lnSpc>
        <a:spcBef>
          <a:spcPts val="187"/>
        </a:spcBef>
        <a:buFont typeface="Arial" panose="020B0604020202020204" pitchFamily="34" charset="0"/>
        <a:buChar char="•"/>
        <a:defRPr sz="673" kern="1200">
          <a:solidFill>
            <a:schemeClr val="tx1"/>
          </a:solidFill>
          <a:latin typeface="+mn-lt"/>
          <a:ea typeface="+mn-ea"/>
          <a:cs typeface="+mn-cs"/>
        </a:defRPr>
      </a:lvl7pPr>
      <a:lvl8pPr marL="1282446" indent="-85496" algn="l" defTabSz="341986" rtl="0" eaLnBrk="1" latinLnBrk="0" hangingPunct="1">
        <a:lnSpc>
          <a:spcPct val="90000"/>
        </a:lnSpc>
        <a:spcBef>
          <a:spcPts val="187"/>
        </a:spcBef>
        <a:buFont typeface="Arial" panose="020B0604020202020204" pitchFamily="34" charset="0"/>
        <a:buChar char="•"/>
        <a:defRPr sz="673" kern="1200">
          <a:solidFill>
            <a:schemeClr val="tx1"/>
          </a:solidFill>
          <a:latin typeface="+mn-lt"/>
          <a:ea typeface="+mn-ea"/>
          <a:cs typeface="+mn-cs"/>
        </a:defRPr>
      </a:lvl8pPr>
      <a:lvl9pPr marL="1453439" indent="-85496" algn="l" defTabSz="341986" rtl="0" eaLnBrk="1" latinLnBrk="0" hangingPunct="1">
        <a:lnSpc>
          <a:spcPct val="90000"/>
        </a:lnSpc>
        <a:spcBef>
          <a:spcPts val="187"/>
        </a:spcBef>
        <a:buFont typeface="Arial" panose="020B0604020202020204" pitchFamily="34" charset="0"/>
        <a:buChar char="•"/>
        <a:defRPr sz="67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1986" rtl="0" eaLnBrk="1" latinLnBrk="0" hangingPunct="1">
        <a:defRPr sz="673" kern="1200">
          <a:solidFill>
            <a:schemeClr val="tx1"/>
          </a:solidFill>
          <a:latin typeface="+mn-lt"/>
          <a:ea typeface="+mn-ea"/>
          <a:cs typeface="+mn-cs"/>
        </a:defRPr>
      </a:lvl1pPr>
      <a:lvl2pPr marL="170993" algn="l" defTabSz="341986" rtl="0" eaLnBrk="1" latinLnBrk="0" hangingPunct="1">
        <a:defRPr sz="673" kern="1200">
          <a:solidFill>
            <a:schemeClr val="tx1"/>
          </a:solidFill>
          <a:latin typeface="+mn-lt"/>
          <a:ea typeface="+mn-ea"/>
          <a:cs typeface="+mn-cs"/>
        </a:defRPr>
      </a:lvl2pPr>
      <a:lvl3pPr marL="341986" algn="l" defTabSz="341986" rtl="0" eaLnBrk="1" latinLnBrk="0" hangingPunct="1">
        <a:defRPr sz="673" kern="1200">
          <a:solidFill>
            <a:schemeClr val="tx1"/>
          </a:solidFill>
          <a:latin typeface="+mn-lt"/>
          <a:ea typeface="+mn-ea"/>
          <a:cs typeface="+mn-cs"/>
        </a:defRPr>
      </a:lvl3pPr>
      <a:lvl4pPr marL="512978" algn="l" defTabSz="341986" rtl="0" eaLnBrk="1" latinLnBrk="0" hangingPunct="1">
        <a:defRPr sz="673" kern="1200">
          <a:solidFill>
            <a:schemeClr val="tx1"/>
          </a:solidFill>
          <a:latin typeface="+mn-lt"/>
          <a:ea typeface="+mn-ea"/>
          <a:cs typeface="+mn-cs"/>
        </a:defRPr>
      </a:lvl4pPr>
      <a:lvl5pPr marL="683971" algn="l" defTabSz="341986" rtl="0" eaLnBrk="1" latinLnBrk="0" hangingPunct="1">
        <a:defRPr sz="673" kern="1200">
          <a:solidFill>
            <a:schemeClr val="tx1"/>
          </a:solidFill>
          <a:latin typeface="+mn-lt"/>
          <a:ea typeface="+mn-ea"/>
          <a:cs typeface="+mn-cs"/>
        </a:defRPr>
      </a:lvl5pPr>
      <a:lvl6pPr marL="854964" algn="l" defTabSz="341986" rtl="0" eaLnBrk="1" latinLnBrk="0" hangingPunct="1">
        <a:defRPr sz="673" kern="1200">
          <a:solidFill>
            <a:schemeClr val="tx1"/>
          </a:solidFill>
          <a:latin typeface="+mn-lt"/>
          <a:ea typeface="+mn-ea"/>
          <a:cs typeface="+mn-cs"/>
        </a:defRPr>
      </a:lvl6pPr>
      <a:lvl7pPr marL="1025957" algn="l" defTabSz="341986" rtl="0" eaLnBrk="1" latinLnBrk="0" hangingPunct="1">
        <a:defRPr sz="673" kern="1200">
          <a:solidFill>
            <a:schemeClr val="tx1"/>
          </a:solidFill>
          <a:latin typeface="+mn-lt"/>
          <a:ea typeface="+mn-ea"/>
          <a:cs typeface="+mn-cs"/>
        </a:defRPr>
      </a:lvl7pPr>
      <a:lvl8pPr marL="1196950" algn="l" defTabSz="341986" rtl="0" eaLnBrk="1" latinLnBrk="0" hangingPunct="1">
        <a:defRPr sz="673" kern="1200">
          <a:solidFill>
            <a:schemeClr val="tx1"/>
          </a:solidFill>
          <a:latin typeface="+mn-lt"/>
          <a:ea typeface="+mn-ea"/>
          <a:cs typeface="+mn-cs"/>
        </a:defRPr>
      </a:lvl8pPr>
      <a:lvl9pPr marL="1367942" algn="l" defTabSz="341986" rtl="0" eaLnBrk="1" latinLnBrk="0" hangingPunct="1">
        <a:defRPr sz="67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tif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tif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tif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tif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tif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tif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tif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tif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tif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tif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tif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tif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>
            <a:extLst>
              <a:ext uri="{FF2B5EF4-FFF2-40B4-BE49-F238E27FC236}">
                <a16:creationId xmlns:a16="http://schemas.microsoft.com/office/drawing/2014/main" id="{FF6E7C56-59BB-4D8A-B4C6-4ECD6774F9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198249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AAD404AA-F522-4782-AF54-F9A02BA46C7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117542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C06EB319-7ED7-460B-90A2-990CB90385B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71459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0C8B0C9-90EA-4009-B64A-9CC47CEF997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331137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DE9CFDE-935C-41D2-A9F6-E52E32238ED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385123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3C8DD537-5415-4633-9890-CE1B19BE81E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79640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7C0BE4C-064F-407D-BA03-74BC32687C2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800625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5EF22CA-3608-49B4-8C81-DCC306875D5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250955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57F411A4-6EA1-4AD0-9738-34A2BA47B2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6394355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F7C53751-C747-4DC9-9ADE-9248E1ADAAB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08346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237E448-6860-4F86-947C-44F6503F769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68095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E5D5D80-B0A7-4C64-BE1E-12676D36D46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781481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F44F1771-62CD-4767-8BDE-119B97BCB02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548179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DCD1C96A-391F-44F6-AD42-5F5428D526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616039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34B5D79-AE3B-429B-9EB7-A08D0CDAF6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1186127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FB2A28D-2338-4176-8BF3-1B532F2193B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29068401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9DDD2F05-D3D7-4079-BF4A-13CEBE29296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2725218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804D3DC-8742-471F-A6EF-3D1A7C0F88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6244533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F2B3D6FD-495A-420A-ABE6-15B5675160B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1661864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66C6D5B-075C-496C-B29A-425DCD9F353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6414632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1BDB84B-31B3-449D-96AD-8F53647B849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6848216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D0A5A443-B193-459D-9C98-5C78C26F185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45756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DF4AEBED-885A-4B48-B6E3-0BCE21AD69D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2561159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CEE552E-D828-4940-9796-A2D9A23DB6B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30439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1370CB07-FB73-42A7-AAD1-7DD36B967C1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98424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048C18F-5375-4AEE-8770-636FE703460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66364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44AA789-E826-41FD-BF18-48D7236B732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04867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CA8BBAFF-893E-4959-8868-8C94E97D1D3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972100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2A58D08-DD6B-4966-B0B3-597C4900B1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115015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CC789D47-C761-496F-937A-64890B9F5B9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50"/>
            <a:ext cx="3419475" cy="4559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31323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0</Words>
  <Application>Microsoft Office PowerPoint</Application>
  <PresentationFormat>自定义</PresentationFormat>
  <Paragraphs>0</Paragraphs>
  <Slides>3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0</vt:i4>
      </vt:variant>
    </vt:vector>
  </HeadingPairs>
  <TitlesOfParts>
    <vt:vector size="34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胡 庭筠</dc:creator>
  <cp:lastModifiedBy>胡 庭筠</cp:lastModifiedBy>
  <cp:revision>2</cp:revision>
  <dcterms:created xsi:type="dcterms:W3CDTF">2020-01-15T11:31:36Z</dcterms:created>
  <dcterms:modified xsi:type="dcterms:W3CDTF">2020-01-21T14:33:02Z</dcterms:modified>
</cp:coreProperties>
</file>